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  <p:sldId id="290" r:id="rId36"/>
    <p:sldId id="291" r:id="rId37"/>
    <p:sldId id="292" r:id="rId38"/>
    <p:sldId id="293" r:id="rId39"/>
    <p:sldId id="294" r:id="rId40"/>
    <p:sldId id="295" r:id="rId41"/>
    <p:sldId id="296" r:id="rId42"/>
    <p:sldId id="297" r:id="rId43"/>
    <p:sldId id="298" r:id="rId44"/>
    <p:sldId id="299" r:id="rId45"/>
    <p:sldId id="300" r:id="rId46"/>
    <p:sldId id="301" r:id="rId47"/>
    <p:sldId id="302" r:id="rId48"/>
    <p:sldId id="303" r:id="rId49"/>
    <p:sldId id="304" r:id="rId50"/>
    <p:sldId id="305" r:id="rId51"/>
    <p:sldId id="306" r:id="rId52"/>
    <p:sldId id="307" r:id="rId53"/>
    <p:sldId id="308" r:id="rId54"/>
    <p:sldId id="309" r:id="rId5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82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774" y="13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presProps" Target="presProp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9680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5204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9275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869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2254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924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8450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9899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5218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7433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8764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88163B-6300-45DB-860E-B3837005BFA5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DCCBCF-C989-479F-8A33-5EC697CF01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5931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1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1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1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1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1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1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1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1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C09596E-9910-4C95-9385-52F0009B68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5870"/>
            <a:ext cx="6858000" cy="803225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502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-ref 50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1091569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19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-ref 175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8FC338D-2B8B-4A08-9639-45D08DAFC5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39132"/>
            <a:ext cx="6858000" cy="28657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915357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502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2-ref 56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6A9E6D1-2A3D-48BE-9ECB-17D9ACD7DC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90467"/>
            <a:ext cx="6858000" cy="39630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020448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12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3a-ref 65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078A1B2-6C10-4892-921F-BA32445F81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91991"/>
            <a:ext cx="6858000" cy="39600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962055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24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3b-ref 61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DECA5EC-EEE8-471A-AE0E-D1A3917E83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12104"/>
            <a:ext cx="6858000" cy="59197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803883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8789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3c&amp;d-ref 80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CDEC42A-E645-4B7E-AD06-869A3ADE10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98030"/>
            <a:ext cx="6858000" cy="39479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358472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17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3e-ref 73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9E7AF0A-85FE-47AB-B17C-2A6482CB4B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53806"/>
            <a:ext cx="6858000" cy="70363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806488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572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3f-ref 81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D78BCE7-6191-43D8-89D8-ECF183E878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03248"/>
            <a:ext cx="6858000" cy="5937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523248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11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3g-ref 82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A5CDBE2-3436-4F8F-A429-DD5878A9F3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45293"/>
            <a:ext cx="6858000" cy="2053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54723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24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3h-ref 45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2C9F976-DC41-4FBA-AD1B-BE26E06086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53191"/>
            <a:ext cx="6858000" cy="2037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722225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29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4a-ref 100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FC3AE0C-6BF5-4186-9D47-7AAA3CF42C5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26172"/>
            <a:ext cx="6858000" cy="7691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56014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502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-ref 69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7386777-90EE-4439-A7C0-1BBEC40E94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03024"/>
            <a:ext cx="6858000" cy="59379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457166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24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4b-ref 69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9897A2D-04E9-4506-949B-F6AE88F9229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03024"/>
            <a:ext cx="6858000" cy="59379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538042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00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4c-ref 56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51B3AA4-5E4B-4FEB-B0EE-A841670F015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90467"/>
            <a:ext cx="6858000" cy="39630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247351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24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4d-ref 50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841F001-03DA-4E5F-AA4E-543B607757C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5870"/>
            <a:ext cx="6858000" cy="80322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910139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12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5a-ref 71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659D8E2-3E9A-490A-8579-1AFFBEACF0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65984"/>
            <a:ext cx="6858000" cy="20120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972968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29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5a-ref 101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ED60BF5-F798-4BA5-9A1C-FC991FC387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99448"/>
            <a:ext cx="6858000" cy="39451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655126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41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5b-ref 103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21B0C56-1AF6-4E32-9781-85E7707277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44536"/>
            <a:ext cx="6858000" cy="2454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946423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00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5c-ref 49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9A13342-4BC9-4355-B8FF-A5CC0F314E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90658"/>
            <a:ext cx="6858000" cy="5962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998802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347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5e-ref 108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E5F1D258-4A88-4685-AB8E-E281143075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19876"/>
            <a:ext cx="6858000" cy="69042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953800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898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5f-ref 109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72F130F-4748-47CE-A0A3-82D577F9D4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99992"/>
            <a:ext cx="6858000" cy="39440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7392271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29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6a-ref 113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C97A112-CA90-4441-B3C6-8BCB8AB66E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13125"/>
            <a:ext cx="6858000" cy="77177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60664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502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-ref 81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40501FD-EFF5-411E-8FA4-1A0A6A83FCA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03248"/>
            <a:ext cx="6858000" cy="5937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285092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41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6b-ref 114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E7B49D9-7C16-4B38-838F-01AD138F91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42592"/>
            <a:ext cx="6858000" cy="4058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0676090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17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6c-ref 115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496B0F9-DA2C-455B-8BD3-C09B9C79D3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91499"/>
            <a:ext cx="6858000" cy="3961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281839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347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6e-ref 126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5C05CCB-1A36-469B-95ED-B6BB4E9382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31521"/>
            <a:ext cx="6858000" cy="50809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1981936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898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6f-ref 123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01EACA2-7422-4CB2-812E-F016BCD2B2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88504"/>
            <a:ext cx="6858000" cy="75669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282348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28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6g-ref 127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B64989B-EED8-4DA4-879D-AEE3D89BD5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57570"/>
            <a:ext cx="6858000" cy="76288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263156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12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7a-ref 38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65D55AC-F46C-4DC7-A3C8-E25B6BC658A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07820"/>
            <a:ext cx="6858000" cy="67283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8229434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41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7b-ref 133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5F668EC-1F83-4796-AB82-A7E401FCC4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84151"/>
            <a:ext cx="6858000" cy="75756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5220879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41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7c-ref 138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509B4E0-B792-4804-AC49-7FD8004543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57371"/>
            <a:ext cx="6858000" cy="68292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2159357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41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7d-ref 139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530F826-67E1-4108-89DA-8C64B92142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74418"/>
            <a:ext cx="6858000" cy="23951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3949139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29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8a-ref 141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DA5649F-1318-40DD-AEC6-ECDDBD41FF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15654"/>
            <a:ext cx="6858000" cy="59126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8051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502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-ref 88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3A1E923-69A7-4523-AF61-D3BA156599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16043"/>
            <a:ext cx="6858000" cy="77119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1485773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29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8a-ref 142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3DE8F83-C9D6-40B8-AA67-D345B4129E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75908"/>
            <a:ext cx="6858000" cy="67921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2888166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41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8b-ref 143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7FD1246-316B-4B07-8280-DEE3F21BB1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61628"/>
            <a:ext cx="6858000" cy="76207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3400871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000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8c-ref 39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5A0A52A-0DED-42DF-BA1A-9F9C8F705A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51414"/>
            <a:ext cx="6858000" cy="28411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0466356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20136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8d&amp;e-ref 145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17196A5-85D0-4E1A-BCE5-8B04E4E667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54558"/>
            <a:ext cx="6858000" cy="76348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6430643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729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9a-ref 151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7C8D77A-E1A4-4ECE-B376-45D72F5023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759" y="3724156"/>
            <a:ext cx="6144482" cy="1695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048429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411892" y="140043"/>
            <a:ext cx="1741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9b-ref 153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15E9D05-0E45-4B9B-BC02-A89C2D5861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68906"/>
            <a:ext cx="6858000" cy="78061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7811408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411892" y="140043"/>
            <a:ext cx="1741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9b-ref 154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3F885B2-86B1-431C-85CB-09C94DF6CE2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08714"/>
            <a:ext cx="6858000" cy="79265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2787885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411892" y="140043"/>
            <a:ext cx="1717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9c-ref 147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D79A21C-25A8-4A8E-A179-1F4DE31C01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20201"/>
            <a:ext cx="6858000" cy="77035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4630367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411892" y="140043"/>
            <a:ext cx="17347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9e-ref 164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194F7CC-BA3A-49F0-BF7B-332149D184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16923"/>
            <a:ext cx="6858000" cy="2110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7935006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411892" y="140043"/>
            <a:ext cx="1846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0a-ref 167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2A68D70-AE9F-4C63-A05B-DC6328DCFF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50139"/>
            <a:ext cx="6858000" cy="2843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64312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19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-ref 134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83B4AB0-0CF6-4D2B-9A9A-CCCAF399249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70138"/>
            <a:ext cx="6858000" cy="76037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6374099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411892" y="140043"/>
            <a:ext cx="1858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0b-ref 168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AD487F0-8558-43C3-AD05-43077D7D6B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71332"/>
            <a:ext cx="6858000" cy="20013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1444819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411892" y="140043"/>
            <a:ext cx="18340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0c-ref 170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F5A94D0-A0DE-47D9-9B35-BD04425EAB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47646"/>
            <a:ext cx="6858000" cy="28487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8693908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411892" y="140043"/>
            <a:ext cx="18469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1a-ref 172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8D112EA-7B16-4B46-9C47-715FA10325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38592"/>
            <a:ext cx="6858000" cy="28668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8234652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411892" y="140043"/>
            <a:ext cx="1858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1b-ref 174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2EC8D76-8ED1-4AFD-9217-AA464CC91F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072923"/>
            <a:ext cx="6858000" cy="9981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9334427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411892" y="140043"/>
            <a:ext cx="1858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/>
              <a:t>Figure11b-ref 175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D39DF62-446E-4EDF-8FFD-938AF109BA5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39132"/>
            <a:ext cx="6858000" cy="28657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87212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19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-ref 138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E09BF8C-A0F6-4AF7-B43C-6E44C548FD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57371"/>
            <a:ext cx="6858000" cy="68292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93851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19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-ref 143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79D018A-68A0-40FA-A9D1-B17A7DD8D3D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61628"/>
            <a:ext cx="6858000" cy="76207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58960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19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-ref 154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2C3B929-8836-4E1E-A4C1-150B76B080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25125"/>
            <a:ext cx="6858000" cy="8093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63114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180B620-B877-4785-94EB-8731E312A41D}"/>
              </a:ext>
            </a:extLst>
          </p:cNvPr>
          <p:cNvSpPr txBox="1"/>
          <p:nvPr/>
        </p:nvSpPr>
        <p:spPr>
          <a:xfrm>
            <a:off x="378941" y="140043"/>
            <a:ext cx="1619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1-ref 167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3BBC2CA-C9F0-4D0D-A24A-3FC7659ED1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57665" y="2318118"/>
            <a:ext cx="6858000" cy="2843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5807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112</Words>
  <Application>Microsoft Office PowerPoint</Application>
  <PresentationFormat>全屏显示(4:3)</PresentationFormat>
  <Paragraphs>54</Paragraphs>
  <Slides>5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4</vt:i4>
      </vt:variant>
    </vt:vector>
  </HeadingPairs>
  <TitlesOfParts>
    <vt:vector size="58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an Ting</dc:creator>
  <cp:lastModifiedBy>Pan Ting</cp:lastModifiedBy>
  <cp:revision>3</cp:revision>
  <dcterms:created xsi:type="dcterms:W3CDTF">2021-05-10T12:14:41Z</dcterms:created>
  <dcterms:modified xsi:type="dcterms:W3CDTF">2021-05-10T12:32:05Z</dcterms:modified>
</cp:coreProperties>
</file>